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5" r:id="rId2"/>
  </p:sldIdLst>
  <p:sldSz cx="12192000" cy="6858000"/>
  <p:notesSz cx="7010400"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6014" autoAdjust="0"/>
    <p:restoredTop sz="93447" autoAdjust="0"/>
  </p:normalViewPr>
  <p:slideViewPr>
    <p:cSldViewPr snapToGrid="0">
      <p:cViewPr varScale="1">
        <p:scale>
          <a:sx n="107" d="100"/>
          <a:sy n="107" d="100"/>
        </p:scale>
        <p:origin x="78" y="13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3407"/>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938" y="0"/>
            <a:ext cx="3037840" cy="463407"/>
          </a:xfrm>
          <a:prstGeom prst="rect">
            <a:avLst/>
          </a:prstGeom>
        </p:spPr>
        <p:txBody>
          <a:bodyPr vert="horz" lIns="91440" tIns="45720" rIns="91440" bIns="45720" rtlCol="0"/>
          <a:lstStyle>
            <a:lvl1pPr algn="r">
              <a:defRPr sz="1200"/>
            </a:lvl1pPr>
          </a:lstStyle>
          <a:p>
            <a:fld id="{A5878891-3B70-4B94-BAEE-88FEB18586E5}" type="datetimeFigureOut">
              <a:rPr lang="en-US" smtClean="0"/>
              <a:t>10/21/2025</a:t>
            </a:fld>
            <a:endParaRPr lang="en-US"/>
          </a:p>
        </p:txBody>
      </p:sp>
      <p:sp>
        <p:nvSpPr>
          <p:cNvPr id="4" name="Slide Image Placeholder 3"/>
          <p:cNvSpPr>
            <a:spLocks noGrp="1" noRot="1" noChangeAspect="1"/>
          </p:cNvSpPr>
          <p:nvPr>
            <p:ph type="sldImg" idx="2"/>
          </p:nvPr>
        </p:nvSpPr>
        <p:spPr>
          <a:xfrm>
            <a:off x="735013" y="1154113"/>
            <a:ext cx="5540375" cy="3116262"/>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040" y="4444861"/>
            <a:ext cx="5608320" cy="363670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9"/>
            <a:ext cx="3037840" cy="463406"/>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772669"/>
            <a:ext cx="3037840" cy="463406"/>
          </a:xfrm>
          <a:prstGeom prst="rect">
            <a:avLst/>
          </a:prstGeom>
        </p:spPr>
        <p:txBody>
          <a:bodyPr vert="horz" lIns="91440" tIns="45720" rIns="91440" bIns="45720" rtlCol="0" anchor="b"/>
          <a:lstStyle>
            <a:lvl1pPr algn="r">
              <a:defRPr sz="1200"/>
            </a:lvl1pPr>
          </a:lstStyle>
          <a:p>
            <a:fld id="{5897DE3F-8F04-476B-AF8E-D0D1D2CF36AF}" type="slidenum">
              <a:rPr lang="en-US" smtClean="0"/>
              <a:t>‹#›</a:t>
            </a:fld>
            <a:endParaRPr lang="en-US"/>
          </a:p>
        </p:txBody>
      </p:sp>
    </p:spTree>
    <p:extLst>
      <p:ext uri="{BB962C8B-B14F-4D97-AF65-F5344CB8AC3E}">
        <p14:creationId xmlns:p14="http://schemas.microsoft.com/office/powerpoint/2010/main" val="33293762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1EFAB3D3-B251-344A-8382-653C787FD628}" type="slidenum">
              <a:rPr lang="en-US" smtClean="0"/>
              <a:t>1</a:t>
            </a:fld>
            <a:endParaRPr lang="en-US"/>
          </a:p>
        </p:txBody>
      </p:sp>
    </p:spTree>
    <p:extLst>
      <p:ext uri="{BB962C8B-B14F-4D97-AF65-F5344CB8AC3E}">
        <p14:creationId xmlns:p14="http://schemas.microsoft.com/office/powerpoint/2010/main" val="5785683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DECF64-62E6-4B8E-90D5-84029C0D69A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EFC55DB-270A-FE06-C0C2-8C3B7960E0B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E36E5E1-EFE0-D916-EE58-848BFE985C13}"/>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7C624415-F5A9-5098-5E2E-9C058724869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45B319-3B47-4B86-1939-2395AC0E0B5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6060702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A48B98-5F78-5FAE-F487-932D8CDB556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050F19-B690-1C98-4C97-C2EB7016593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A47D955-E84D-DA92-71E0-19983DE7EE3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26EE7442-0FA0-0662-4880-EB70B5A386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0A60A8C-DACC-C25D-EA31-2286374737F2}"/>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9914730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AFAA582-80EA-8FFE-6717-8F7660FD22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006AB09-1D1B-598A-3196-87DE1F9B810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41D5950-191C-D2E6-3974-A35C46151C9A}"/>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FFE24EE5-9452-84DF-1A7F-3D2E1C52CE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04FCC4B-8E7D-2B5D-0791-B950B76224E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83699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7103AE-2CA8-D316-AFE5-E63ABEA0986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4C24A61-629B-67A4-921D-8E595D3372D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B1DC599-085D-F352-6523-1CE8CB325E87}"/>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E2056BCE-8FDD-DC7C-BFA2-646FCFD7F6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0E68B1-7026-6D9A-AA6F-86D5A2244AC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84700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159DE-46C7-7112-D8F4-AC0846F4D4C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751615-850B-8EE3-CD07-A41BCC96B02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D6D6D35-6EEE-76CB-A7B3-9393C6285B91}"/>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AEE1BD30-B32D-92E3-8943-51DD5C00566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03268-9725-9EEB-4396-3DC7FE27B90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872064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8EA0BF-849F-9564-DDCD-9D6E2F52E8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9B608DA-F013-88F9-DECC-12F3D99742B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1B9CD44-76E8-EB8B-4F78-D717428AF94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83A4DA9-3BC5-6799-6BA0-C4C1991711AD}"/>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7050E6D9-1A18-C6B4-92F5-CFF5A6A408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A9BB7A-3135-2BF6-6401-D24789835F98}"/>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5428245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2FAC7F-C16F-D8C4-3D2E-AD085291B3B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1FF2890-2C17-37FD-0A84-F3892166DD2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305EA2C-667E-3AB7-E26B-8A78C667B47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9F41096-C25D-2831-01D7-2D3B934545D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F951FEE-E9E0-6A8E-CE16-01F17AD753B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F5F7DA7-B82C-D8DB-4CB6-A2EBB76DAB39}"/>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8" name="Footer Placeholder 7">
            <a:extLst>
              <a:ext uri="{FF2B5EF4-FFF2-40B4-BE49-F238E27FC236}">
                <a16:creationId xmlns:a16="http://schemas.microsoft.com/office/drawing/2014/main" id="{04914E22-4792-AF32-96EE-BA1F85350A7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312D419-4CC5-FE70-6BE4-A530667D1FE7}"/>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375992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66F74C-1488-E29C-0EF7-29815B736E4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1B1ADC-5E07-A38D-9B4D-54BDEEA376C2}"/>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4" name="Footer Placeholder 3">
            <a:extLst>
              <a:ext uri="{FF2B5EF4-FFF2-40B4-BE49-F238E27FC236}">
                <a16:creationId xmlns:a16="http://schemas.microsoft.com/office/drawing/2014/main" id="{FFD3A60B-1623-0F7E-17FA-23C909281CE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73969C3-F1A5-90A5-D54E-E6258A2D44DD}"/>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9066122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51E7637-6E7A-283C-6283-60359DF8E83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3" name="Footer Placeholder 2">
            <a:extLst>
              <a:ext uri="{FF2B5EF4-FFF2-40B4-BE49-F238E27FC236}">
                <a16:creationId xmlns:a16="http://schemas.microsoft.com/office/drawing/2014/main" id="{E7E4978E-B117-9941-29EC-A70E0FA980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FD7E27-B98F-6776-573A-EBACEC9A485C}"/>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50792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DCCCB-1A48-3A52-BAE1-BFED42D5457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2934DA0-DFB0-DE2B-9DD5-A6E08348AD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925438A-98D3-6F12-5556-FD99DD4489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FD4AED-5D58-CA1B-FD3F-15506906C2F0}"/>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F79CB4F1-064F-7EE5-ECD7-3AF1818204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16C0817-EA96-463A-7FC5-0238C772BE99}"/>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28124982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25C869-05BF-9F9A-18D3-0662AB90AAD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0CA6735-F013-975D-91C3-36205A93832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7843637-448B-0412-ED75-BFAC61BA7F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EF5FAF-7C11-BCAF-C5F7-9DB8DF122AAE}"/>
              </a:ext>
            </a:extLst>
          </p:cNvPr>
          <p:cNvSpPr>
            <a:spLocks noGrp="1"/>
          </p:cNvSpPr>
          <p:nvPr>
            <p:ph type="dt" sz="half" idx="10"/>
          </p:nvPr>
        </p:nvSpPr>
        <p:spPr/>
        <p:txBody>
          <a:bodyPr/>
          <a:lstStyle/>
          <a:p>
            <a:fld id="{B800D2AE-1854-4865-8E28-7F0D0DB748FF}" type="datetimeFigureOut">
              <a:rPr lang="en-US" smtClean="0"/>
              <a:t>10/21/2025</a:t>
            </a:fld>
            <a:endParaRPr lang="en-US"/>
          </a:p>
        </p:txBody>
      </p:sp>
      <p:sp>
        <p:nvSpPr>
          <p:cNvPr id="6" name="Footer Placeholder 5">
            <a:extLst>
              <a:ext uri="{FF2B5EF4-FFF2-40B4-BE49-F238E27FC236}">
                <a16:creationId xmlns:a16="http://schemas.microsoft.com/office/drawing/2014/main" id="{43637007-F46F-052B-F5EC-2C05A50B96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9C9CED-02A8-286D-37DD-8F866DB2316E}"/>
              </a:ext>
            </a:extLst>
          </p:cNvPr>
          <p:cNvSpPr>
            <a:spLocks noGrp="1"/>
          </p:cNvSpPr>
          <p:nvPr>
            <p:ph type="sldNum" sz="quarter" idx="12"/>
          </p:nvPr>
        </p:nvSpPr>
        <p:spPr/>
        <p:txBody>
          <a:bodyPr/>
          <a:lstStyle/>
          <a:p>
            <a:fld id="{63881D2E-E029-4622-A508-9B9C13E12A34}" type="slidenum">
              <a:rPr lang="en-US" smtClean="0"/>
              <a:t>‹#›</a:t>
            </a:fld>
            <a:endParaRPr lang="en-US"/>
          </a:p>
        </p:txBody>
      </p:sp>
    </p:spTree>
    <p:extLst>
      <p:ext uri="{BB962C8B-B14F-4D97-AF65-F5344CB8AC3E}">
        <p14:creationId xmlns:p14="http://schemas.microsoft.com/office/powerpoint/2010/main" val="17348315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D47AEBF-16CF-0A62-F011-6A11A4E9983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401EB9A-1BFA-5855-3D70-BBE95E170F5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F12A36-4D3F-6E80-E41F-79314E92005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00D2AE-1854-4865-8E28-7F0D0DB748FF}" type="datetimeFigureOut">
              <a:rPr lang="en-US" smtClean="0"/>
              <a:t>10/21/2025</a:t>
            </a:fld>
            <a:endParaRPr lang="en-US"/>
          </a:p>
        </p:txBody>
      </p:sp>
      <p:sp>
        <p:nvSpPr>
          <p:cNvPr id="5" name="Footer Placeholder 4">
            <a:extLst>
              <a:ext uri="{FF2B5EF4-FFF2-40B4-BE49-F238E27FC236}">
                <a16:creationId xmlns:a16="http://schemas.microsoft.com/office/drawing/2014/main" id="{85249328-9A8E-A056-517B-F9FD5B9D88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A80532B-B214-6D1B-94CE-81305ED7ABA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3881D2E-E029-4622-A508-9B9C13E12A34}" type="slidenum">
              <a:rPr lang="en-US" smtClean="0"/>
              <a:t>‹#›</a:t>
            </a:fld>
            <a:endParaRPr lang="en-US"/>
          </a:p>
        </p:txBody>
      </p:sp>
    </p:spTree>
    <p:extLst>
      <p:ext uri="{BB962C8B-B14F-4D97-AF65-F5344CB8AC3E}">
        <p14:creationId xmlns:p14="http://schemas.microsoft.com/office/powerpoint/2010/main" val="10102333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chart of different colored bars&#10;&#10;Description automatically generated">
            <a:extLst>
              <a:ext uri="{FF2B5EF4-FFF2-40B4-BE49-F238E27FC236}">
                <a16:creationId xmlns:a16="http://schemas.microsoft.com/office/drawing/2014/main" id="{F432F147-634D-0695-84DD-875523C13CA7}"/>
              </a:ext>
            </a:extLst>
          </p:cNvPr>
          <p:cNvPicPr>
            <a:picLocks noChangeAspect="1"/>
          </p:cNvPicPr>
          <p:nvPr/>
        </p:nvPicPr>
        <p:blipFill>
          <a:blip r:embed="rId3"/>
          <a:stretch>
            <a:fillRect/>
          </a:stretch>
        </p:blipFill>
        <p:spPr>
          <a:xfrm>
            <a:off x="162223" y="195229"/>
            <a:ext cx="12616892" cy="6625817"/>
          </a:xfrm>
          <a:prstGeom prst="rect">
            <a:avLst/>
          </a:prstGeom>
        </p:spPr>
      </p:pic>
      <p:sp>
        <p:nvSpPr>
          <p:cNvPr id="3" name="TextBox 2">
            <a:extLst>
              <a:ext uri="{FF2B5EF4-FFF2-40B4-BE49-F238E27FC236}">
                <a16:creationId xmlns:a16="http://schemas.microsoft.com/office/drawing/2014/main" id="{5C6155AD-756B-01A0-A356-D16FF5D38FFB}"/>
              </a:ext>
            </a:extLst>
          </p:cNvPr>
          <p:cNvSpPr txBox="1"/>
          <p:nvPr/>
        </p:nvSpPr>
        <p:spPr>
          <a:xfrm>
            <a:off x="162223" y="6347012"/>
            <a:ext cx="11949095" cy="507831"/>
          </a:xfrm>
          <a:prstGeom prst="rect">
            <a:avLst/>
          </a:prstGeom>
          <a:noFill/>
        </p:spPr>
        <p:txBody>
          <a:bodyPr wrap="square" rtlCol="0">
            <a:spAutoFit/>
          </a:bodyPr>
          <a:lstStyle/>
          <a:p>
            <a:r>
              <a:rPr lang="en-US" sz="900" b="1" dirty="0">
                <a:effectLst/>
                <a:latin typeface="Arial" panose="020B0604020202020204" pitchFamily="34" charset="0"/>
                <a:ea typeface="SimSun" panose="02010600030101010101" pitchFamily="2" charset="-122"/>
                <a:cs typeface="Times New Roman" panose="02020603050405020304" pitchFamily="18" charset="0"/>
              </a:rPr>
              <a:t>Supplementary Figure 7. Summary of top mutated genes in solid tissue and longitudinal liquid biopsy samples.</a:t>
            </a:r>
            <a:r>
              <a:rPr lang="en-US" sz="900" dirty="0">
                <a:effectLst/>
                <a:latin typeface="Arial" panose="020B0604020202020204" pitchFamily="34" charset="0"/>
                <a:ea typeface="SimSun" panose="02010600030101010101" pitchFamily="2" charset="-122"/>
                <a:cs typeface="Times New Roman" panose="02020603050405020304" pitchFamily="18" charset="0"/>
              </a:rPr>
              <a:t> Shown are the top genes found to be mutated across the solid tissue at diagnosis (T), at entry into trial (0), at W12 on palbociclib treatment (3) and W24 (6). Where available, molecular subtyping results are also shown as well as PFS status. White and blue colored boxes represent the VAF of mutations observed in cfDNA, with white reflecting a VAF of 0. Black boxes indicate that the patient did not have a cfDNA profiled at that time point. </a:t>
            </a:r>
            <a:endParaRPr lang="en-US" sz="9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25531151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8847</TotalTime>
  <Words>111</Words>
  <Application>Microsoft Office PowerPoint</Application>
  <PresentationFormat>Widescreen</PresentationFormat>
  <Paragraphs>2</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ne Bayani</dc:creator>
  <cp:lastModifiedBy>Quann, Karen</cp:lastModifiedBy>
  <cp:revision>308</cp:revision>
  <cp:lastPrinted>2023-08-16T18:12:39Z</cp:lastPrinted>
  <dcterms:created xsi:type="dcterms:W3CDTF">2023-05-04T15:52:47Z</dcterms:created>
  <dcterms:modified xsi:type="dcterms:W3CDTF">2025-10-21T17:24:29Z</dcterms:modified>
</cp:coreProperties>
</file>